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4" d="100"/>
          <a:sy n="74" d="100"/>
        </p:scale>
        <p:origin x="-1392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710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458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398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791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610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649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744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531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908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76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649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824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6.jpeg"/><Relationship Id="rId12" Type="http://schemas.microsoft.com/office/2007/relationships/hdphoto" Target="../media/hdphoto5.wdp"/><Relationship Id="rId13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eg"/><Relationship Id="rId7" Type="http://schemas.microsoft.com/office/2007/relationships/hdphoto" Target="../media/hdphoto3.wdp"/><Relationship Id="rId8" Type="http://schemas.openxmlformats.org/officeDocument/2006/relationships/image" Target="../media/image4.png"/><Relationship Id="rId9" Type="http://schemas.microsoft.com/office/2007/relationships/hdphoto" Target="../media/hdphoto4.wdp"/><Relationship Id="rId10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304800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76200" y="-23408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l </a:t>
            </a:r>
            <a:r>
              <a:rPr lang="en-US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. 3 </a:t>
            </a:r>
            <a:endParaRPr lang="en-US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72" name="Group 71"/>
          <p:cNvGrpSpPr/>
          <p:nvPr/>
        </p:nvGrpSpPr>
        <p:grpSpPr>
          <a:xfrm>
            <a:off x="1258802" y="621851"/>
            <a:ext cx="3977736" cy="1620299"/>
            <a:chOff x="1194662" y="212807"/>
            <a:chExt cx="3977736" cy="1620299"/>
          </a:xfrm>
        </p:grpSpPr>
        <p:pic>
          <p:nvPicPr>
            <p:cNvPr id="1026" name="Picture 2" descr="I:\Grad Students\2014_12_30\IMG_0003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786" t="26993" r="12177" b="60686"/>
            <a:stretch/>
          </p:blipFill>
          <p:spPr bwMode="auto">
            <a:xfrm flipH="1">
              <a:off x="2058987" y="1013956"/>
              <a:ext cx="1438275" cy="8191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" name="Picture 2" descr="I:\Grad Students\2014_12_30\IMG_0003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18" t="26850" r="55144" b="60830"/>
            <a:stretch/>
          </p:blipFill>
          <p:spPr bwMode="auto">
            <a:xfrm flipH="1">
              <a:off x="3668712" y="1013956"/>
              <a:ext cx="1428752" cy="8191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" name="Group 10"/>
            <p:cNvGrpSpPr/>
            <p:nvPr/>
          </p:nvGrpSpPr>
          <p:grpSpPr>
            <a:xfrm>
              <a:off x="1194662" y="374824"/>
              <a:ext cx="973387" cy="664695"/>
              <a:chOff x="1154973" y="1380168"/>
              <a:chExt cx="973387" cy="664695"/>
            </a:xfrm>
          </p:grpSpPr>
          <p:cxnSp>
            <p:nvCxnSpPr>
              <p:cNvPr id="4" name="Straight Connector 3"/>
              <p:cNvCxnSpPr/>
              <p:nvPr/>
            </p:nvCxnSpPr>
            <p:spPr>
              <a:xfrm>
                <a:off x="1563274" y="1503166"/>
                <a:ext cx="475481" cy="54169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" name="TextBox 4"/>
              <p:cNvSpPr txBox="1"/>
              <p:nvPr/>
            </p:nvSpPr>
            <p:spPr>
              <a:xfrm>
                <a:off x="1521280" y="1380168"/>
                <a:ext cx="607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l4ad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154973" y="1637343"/>
                <a:ext cx="607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l4bd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 rot="18066521">
              <a:off x="3585478" y="664334"/>
              <a:ext cx="607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V4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8066521">
              <a:off x="2447047" y="539287"/>
              <a:ext cx="899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D2(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8066521">
              <a:off x="4056772" y="539287"/>
              <a:ext cx="899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D2(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8066521">
              <a:off x="3018547" y="539287"/>
              <a:ext cx="899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D2 NP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8066521">
              <a:off x="4599697" y="539287"/>
              <a:ext cx="899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D2 NP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507502" y="1058339"/>
              <a:ext cx="7419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p53       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574956" y="1555445"/>
              <a:ext cx="674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 EHD2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8066521">
              <a:off x="2013853" y="664334"/>
              <a:ext cx="607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V4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" name="Group 80"/>
          <p:cNvGrpSpPr/>
          <p:nvPr/>
        </p:nvGrpSpPr>
        <p:grpSpPr>
          <a:xfrm>
            <a:off x="3794764" y="2252373"/>
            <a:ext cx="1456060" cy="2177781"/>
            <a:chOff x="3802063" y="1843329"/>
            <a:chExt cx="1456060" cy="2177781"/>
          </a:xfrm>
        </p:grpSpPr>
        <p:pic>
          <p:nvPicPr>
            <p:cNvPr id="16" name="Picture 2" descr="I:\Grad Students\kriti\2015_01_08\IMG_0003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966" t="16250" r="12684" b="62187"/>
            <a:stretch/>
          </p:blipFill>
          <p:spPr bwMode="auto">
            <a:xfrm flipH="1">
              <a:off x="3802063" y="2639844"/>
              <a:ext cx="1400177" cy="138126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" name="TextBox 19"/>
            <p:cNvSpPr txBox="1"/>
            <p:nvPr/>
          </p:nvSpPr>
          <p:spPr>
            <a:xfrm rot="18066521">
              <a:off x="3728353" y="2294856"/>
              <a:ext cx="607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V4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rot="18066521">
              <a:off x="4161547" y="2169809"/>
              <a:ext cx="899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D2(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8066521">
              <a:off x="4685422" y="2169809"/>
              <a:ext cx="899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D2 NP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5" name="Group 74"/>
          <p:cNvGrpSpPr/>
          <p:nvPr/>
        </p:nvGrpSpPr>
        <p:grpSpPr>
          <a:xfrm>
            <a:off x="1264846" y="2252373"/>
            <a:ext cx="2395192" cy="2177781"/>
            <a:chOff x="1291306" y="1843329"/>
            <a:chExt cx="2395192" cy="2177781"/>
          </a:xfrm>
        </p:grpSpPr>
        <p:sp>
          <p:nvSpPr>
            <p:cNvPr id="7" name="TextBox 6"/>
            <p:cNvSpPr txBox="1"/>
            <p:nvPr/>
          </p:nvSpPr>
          <p:spPr>
            <a:xfrm rot="18066521">
              <a:off x="2128153" y="2294856"/>
              <a:ext cx="607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V4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Picture 16" descr="I:\Grad Students\kriti\2015_01_08\IMG_0003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66" t="16250" r="60171" b="62187"/>
            <a:stretch/>
          </p:blipFill>
          <p:spPr bwMode="auto">
            <a:xfrm flipH="1">
              <a:off x="2173288" y="2639844"/>
              <a:ext cx="1419224" cy="138126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" name="TextBox 22"/>
            <p:cNvSpPr txBox="1"/>
            <p:nvPr/>
          </p:nvSpPr>
          <p:spPr>
            <a:xfrm rot="18066521">
              <a:off x="2561347" y="2169809"/>
              <a:ext cx="899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D2(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629643" y="2794325"/>
              <a:ext cx="7419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p53       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8066521">
              <a:off x="3113797" y="2169809"/>
              <a:ext cx="899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D2 NP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438877" y="3239144"/>
              <a:ext cx="11145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cs typeface="Arial"/>
                </a:rPr>
                <a:t>MICAL-L1</a:t>
              </a: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291595" y="3736886"/>
              <a:ext cx="1066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   </a:t>
              </a:r>
              <a:r>
                <a:rPr lang="en-US" sz="11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Syndapin2</a:t>
              </a:r>
              <a:endParaRPr lang="en-US" sz="11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32" name="Group 31"/>
            <p:cNvGrpSpPr/>
            <p:nvPr/>
          </p:nvGrpSpPr>
          <p:grpSpPr>
            <a:xfrm>
              <a:off x="1291306" y="1987236"/>
              <a:ext cx="973387" cy="664695"/>
              <a:chOff x="1154973" y="1380168"/>
              <a:chExt cx="973387" cy="664695"/>
            </a:xfrm>
          </p:grpSpPr>
          <p:cxnSp>
            <p:nvCxnSpPr>
              <p:cNvPr id="33" name="Straight Connector 32"/>
              <p:cNvCxnSpPr/>
              <p:nvPr/>
            </p:nvCxnSpPr>
            <p:spPr>
              <a:xfrm>
                <a:off x="1563274" y="1503166"/>
                <a:ext cx="475481" cy="54169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/>
              <p:cNvSpPr txBox="1"/>
              <p:nvPr/>
            </p:nvSpPr>
            <p:spPr>
              <a:xfrm>
                <a:off x="1521280" y="1380168"/>
                <a:ext cx="607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l4ad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154973" y="1637343"/>
                <a:ext cx="607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l4bd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4" name="Group 83"/>
          <p:cNvGrpSpPr/>
          <p:nvPr/>
        </p:nvGrpSpPr>
        <p:grpSpPr>
          <a:xfrm>
            <a:off x="1234078" y="4828644"/>
            <a:ext cx="4103569" cy="4086756"/>
            <a:chOff x="1234078" y="5057244"/>
            <a:chExt cx="4103569" cy="4086756"/>
          </a:xfrm>
        </p:grpSpPr>
        <p:grpSp>
          <p:nvGrpSpPr>
            <p:cNvPr id="82" name="Group 81"/>
            <p:cNvGrpSpPr/>
            <p:nvPr/>
          </p:nvGrpSpPr>
          <p:grpSpPr>
            <a:xfrm>
              <a:off x="1234078" y="5057244"/>
              <a:ext cx="4103569" cy="1821704"/>
              <a:chOff x="1234078" y="4813493"/>
              <a:chExt cx="4103569" cy="1821704"/>
            </a:xfrm>
          </p:grpSpPr>
          <p:grpSp>
            <p:nvGrpSpPr>
              <p:cNvPr id="77" name="Group 76"/>
              <p:cNvGrpSpPr/>
              <p:nvPr/>
            </p:nvGrpSpPr>
            <p:grpSpPr>
              <a:xfrm>
                <a:off x="3692849" y="4813493"/>
                <a:ext cx="1644798" cy="1821704"/>
                <a:chOff x="3601191" y="4813493"/>
                <a:chExt cx="1644798" cy="1821704"/>
              </a:xfrm>
            </p:grpSpPr>
            <p:pic>
              <p:nvPicPr>
                <p:cNvPr id="38" name="Picture 2" descr="I:\Grad Students\kriti\2015_01_08\IMG_0002.jpg"/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20000" contrast="7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0917" t="59167" r="9528" b="25937"/>
                <a:stretch/>
              </p:blipFill>
              <p:spPr bwMode="auto">
                <a:xfrm flipH="1">
                  <a:off x="3601191" y="5598247"/>
                  <a:ext cx="1479054" cy="103695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44" name="TextBox 43"/>
                <p:cNvSpPr txBox="1"/>
                <p:nvPr/>
              </p:nvSpPr>
              <p:spPr>
                <a:xfrm rot="18066521">
                  <a:off x="3670359" y="5265020"/>
                  <a:ext cx="60708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V40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 rot="18066521">
                  <a:off x="4065453" y="5139973"/>
                  <a:ext cx="89918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HD2(</a:t>
                  </a:r>
                  <a:r>
                    <a:rPr lang="en-US" sz="10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 rot="18066521">
                  <a:off x="4673288" y="5139973"/>
                  <a:ext cx="89918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HD2 NFP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8" name="Group 77"/>
              <p:cNvGrpSpPr/>
              <p:nvPr/>
            </p:nvGrpSpPr>
            <p:grpSpPr>
              <a:xfrm>
                <a:off x="1234078" y="4813493"/>
                <a:ext cx="2482407" cy="1821704"/>
                <a:chOff x="965122" y="4813493"/>
                <a:chExt cx="2482407" cy="1821704"/>
              </a:xfrm>
            </p:grpSpPr>
            <p:pic>
              <p:nvPicPr>
                <p:cNvPr id="39" name="Picture 38" descr="I:\Grad Students\kriti\2015_01_08\IMG_0002.jpg"/>
                <p:cNvPicPr>
                  <a:picLocks noChangeAspect="1" noChangeArrowheads="1"/>
                </p:cNvPicPr>
                <p:nvPr/>
              </p:nvPicPr>
              <p:blipFill rotWithShape="1">
                <a:blip r:embed="rId10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21000" contrast="7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153" t="59167" r="59966" b="25937"/>
                <a:stretch/>
              </p:blipFill>
              <p:spPr bwMode="auto">
                <a:xfrm flipH="1">
                  <a:off x="1877169" y="5598247"/>
                  <a:ext cx="1495424" cy="103695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65" name="Group 64"/>
                <p:cNvGrpSpPr/>
                <p:nvPr/>
              </p:nvGrpSpPr>
              <p:grpSpPr>
                <a:xfrm>
                  <a:off x="965122" y="4946361"/>
                  <a:ext cx="1078001" cy="653040"/>
                  <a:chOff x="1157542" y="4946361"/>
                  <a:chExt cx="1078001" cy="653040"/>
                </a:xfrm>
              </p:grpSpPr>
              <p:cxnSp>
                <p:nvCxnSpPr>
                  <p:cNvPr id="40" name="Straight Connector 39"/>
                  <p:cNvCxnSpPr/>
                  <p:nvPr/>
                </p:nvCxnSpPr>
                <p:spPr>
                  <a:xfrm>
                    <a:off x="1604039" y="5057704"/>
                    <a:ext cx="475481" cy="541697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1" name="TextBox 40"/>
                  <p:cNvSpPr txBox="1"/>
                  <p:nvPr/>
                </p:nvSpPr>
                <p:spPr>
                  <a:xfrm>
                    <a:off x="1628463" y="4946361"/>
                    <a:ext cx="60708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l4ad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1157542" y="5155560"/>
                    <a:ext cx="60708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l4bd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3" name="TextBox 42"/>
                <p:cNvSpPr txBox="1"/>
                <p:nvPr/>
              </p:nvSpPr>
              <p:spPr>
                <a:xfrm rot="18066521">
                  <a:off x="1851084" y="5265020"/>
                  <a:ext cx="60708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V40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 rot="18066521">
                  <a:off x="2360478" y="5139973"/>
                  <a:ext cx="89918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HD2(</a:t>
                  </a:r>
                  <a:r>
                    <a:rPr lang="en-US" sz="10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 rot="18066521">
                  <a:off x="2874828" y="5139973"/>
                  <a:ext cx="89918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HD2 NFP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1329209" y="5728785"/>
                  <a:ext cx="74198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p53       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1383408" y="6238281"/>
                  <a:ext cx="67453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 EHD2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</p:grpSp>
        <p:pic>
          <p:nvPicPr>
            <p:cNvPr id="52" name="Picture 3" descr="I:\Grad Students\kriti\2015_01_15\IMG_0003.jpg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1000" contrast="7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275" t="33210" r="13978" b="45935"/>
            <a:stretch/>
          </p:blipFill>
          <p:spPr bwMode="auto">
            <a:xfrm flipH="1">
              <a:off x="3708194" y="7650288"/>
              <a:ext cx="1502988" cy="149371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7" name="TextBox 56"/>
            <p:cNvSpPr txBox="1"/>
            <p:nvPr/>
          </p:nvSpPr>
          <p:spPr>
            <a:xfrm rot="18066521">
              <a:off x="3591240" y="7307200"/>
              <a:ext cx="607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V4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 rot="18066521">
              <a:off x="4100634" y="7182153"/>
              <a:ext cx="899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D2(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rot="18066521">
              <a:off x="4733314" y="7182153"/>
              <a:ext cx="899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D2 NFP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9" name="Group 78"/>
            <p:cNvGrpSpPr/>
            <p:nvPr/>
          </p:nvGrpSpPr>
          <p:grpSpPr>
            <a:xfrm>
              <a:off x="1246307" y="6855673"/>
              <a:ext cx="2440174" cy="2288327"/>
              <a:chOff x="1052061" y="6855673"/>
              <a:chExt cx="2440174" cy="2288327"/>
            </a:xfrm>
          </p:grpSpPr>
          <p:pic>
            <p:nvPicPr>
              <p:cNvPr id="51" name="Picture 3" descr="I:\Grad Students\kriti\2015_01_15\IMG_0003.jpg"/>
              <p:cNvPicPr>
                <a:picLocks noChangeAspect="1" noChangeArrowheads="1"/>
              </p:cNvPicPr>
              <p:nvPr/>
            </p:nvPicPr>
            <p:blipFill rotWithShape="1">
              <a:blip r:embed="rId13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17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515" t="34248" r="61919" b="44896"/>
              <a:stretch/>
            </p:blipFill>
            <p:spPr bwMode="auto">
              <a:xfrm flipH="1">
                <a:off x="1967676" y="7650288"/>
                <a:ext cx="1493463" cy="149371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4" name="TextBox 53"/>
              <p:cNvSpPr txBox="1"/>
              <p:nvPr/>
            </p:nvSpPr>
            <p:spPr>
              <a:xfrm rot="18066521">
                <a:off x="2338509" y="7182153"/>
                <a:ext cx="89918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HD2(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 rot="18066521">
                <a:off x="1867215" y="7307200"/>
                <a:ext cx="607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V4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 rot="18066521">
                <a:off x="2919534" y="7182153"/>
                <a:ext cx="89918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HD2 NFP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1400525" y="7671885"/>
                <a:ext cx="74198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p53       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059232" y="8194881"/>
                <a:ext cx="1066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   </a:t>
                </a:r>
                <a:r>
                  <a:rPr lang="en-US" sz="11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Syndapin2</a:t>
                </a:r>
                <a:endParaRPr lang="en-US" sz="11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1206413" y="8784954"/>
                <a:ext cx="11145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/>
                    <a:cs typeface="Arial"/>
                  </a:rPr>
                  <a:t>MICAL-L1</a:t>
                </a:r>
                <a:endParaRPr kumimoji="0" lang="en-US" sz="11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/>
                  <a:cs typeface="Arial"/>
                </a:endParaRPr>
              </a:p>
            </p:txBody>
          </p:sp>
          <p:grpSp>
            <p:nvGrpSpPr>
              <p:cNvPr id="67" name="Group 66"/>
              <p:cNvGrpSpPr/>
              <p:nvPr/>
            </p:nvGrpSpPr>
            <p:grpSpPr>
              <a:xfrm>
                <a:off x="1052061" y="7012274"/>
                <a:ext cx="1078001" cy="653040"/>
                <a:chOff x="1157542" y="4946361"/>
                <a:chExt cx="1078001" cy="653040"/>
              </a:xfrm>
            </p:grpSpPr>
            <p:cxnSp>
              <p:nvCxnSpPr>
                <p:cNvPr id="68" name="Straight Connector 67"/>
                <p:cNvCxnSpPr/>
                <p:nvPr/>
              </p:nvCxnSpPr>
              <p:spPr>
                <a:xfrm>
                  <a:off x="1604039" y="5057704"/>
                  <a:ext cx="475481" cy="54169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9" name="TextBox 68"/>
                <p:cNvSpPr txBox="1"/>
                <p:nvPr/>
              </p:nvSpPr>
              <p:spPr>
                <a:xfrm>
                  <a:off x="1628463" y="4946361"/>
                  <a:ext cx="60708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l4ad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1157542" y="5155560"/>
                  <a:ext cx="60708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l4bd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86" name="Rectangle 85"/>
          <p:cNvSpPr/>
          <p:nvPr/>
        </p:nvSpPr>
        <p:spPr>
          <a:xfrm>
            <a:off x="1219200" y="457200"/>
            <a:ext cx="4343400" cy="4191000"/>
          </a:xfrm>
          <a:prstGeom prst="rect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/>
          <p:cNvSpPr/>
          <p:nvPr/>
        </p:nvSpPr>
        <p:spPr>
          <a:xfrm>
            <a:off x="1219200" y="4800600"/>
            <a:ext cx="4343400" cy="4191000"/>
          </a:xfrm>
          <a:prstGeom prst="rect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839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0</Words>
  <Application>Microsoft Macintosh PowerPoint</Application>
  <PresentationFormat>On-screen Show (4:3)</PresentationFormat>
  <Paragraphs>4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Caplan</dc:creator>
  <cp:lastModifiedBy>Steve Caplan</cp:lastModifiedBy>
  <cp:revision>2</cp:revision>
  <dcterms:created xsi:type="dcterms:W3CDTF">2015-01-19T19:54:23Z</dcterms:created>
  <dcterms:modified xsi:type="dcterms:W3CDTF">2015-01-19T19:55:59Z</dcterms:modified>
</cp:coreProperties>
</file>